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90011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98" autoAdjust="0"/>
    <p:restoredTop sz="94641" autoAdjust="0"/>
  </p:normalViewPr>
  <p:slideViewPr>
    <p:cSldViewPr snapToGrid="0">
      <p:cViewPr>
        <p:scale>
          <a:sx n="56" d="100"/>
          <a:sy n="56" d="100"/>
        </p:scale>
        <p:origin x="-1004" y="-72"/>
      </p:cViewPr>
      <p:guideLst>
        <p:guide orient="horz" pos="2835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CE32AE-332F-4D8A-8473-BDA138FE9CF9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08075" y="685800"/>
            <a:ext cx="4641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8ED8B2-07D8-491C-806F-CB285B233A0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473101"/>
            <a:ext cx="9144000" cy="3133725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4727675"/>
            <a:ext cx="9144000" cy="2173188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102564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81448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479227"/>
            <a:ext cx="2628900" cy="762803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479227"/>
            <a:ext cx="7734300" cy="762803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844124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723021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3" y="2244035"/>
            <a:ext cx="10515600" cy="374421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3" y="6023675"/>
            <a:ext cx="10515600" cy="196899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262171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1" y="2396133"/>
            <a:ext cx="5181600" cy="571113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1" y="2396133"/>
            <a:ext cx="5181600" cy="571113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055465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90" y="479231"/>
            <a:ext cx="10515600" cy="173980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91" y="2206528"/>
            <a:ext cx="5157787" cy="10813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91" y="3287912"/>
            <a:ext cx="5157787" cy="483602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2" y="2206528"/>
            <a:ext cx="5183188" cy="10813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2" y="3287912"/>
            <a:ext cx="5183188" cy="483602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042663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178772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243841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90" y="600075"/>
            <a:ext cx="3932236" cy="210026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9" y="1296000"/>
            <a:ext cx="6172201" cy="63966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90" y="2700338"/>
            <a:ext cx="3932236" cy="500270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928286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90" y="600075"/>
            <a:ext cx="3932236" cy="210026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9" y="1296000"/>
            <a:ext cx="6172201" cy="639663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90" y="2700338"/>
            <a:ext cx="3932236" cy="500270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713077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2" y="479231"/>
            <a:ext cx="10515600" cy="1739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2" y="2396133"/>
            <a:ext cx="10515600" cy="57111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1" y="8342714"/>
            <a:ext cx="2743200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BF4F0-293F-4C7B-A295-DDE2E85B868A}" type="datetimeFigureOut">
              <a:rPr lang="zh-CN" altLang="en-US" smtClean="0"/>
              <a:pPr/>
              <a:t>2017/9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2" y="8342714"/>
            <a:ext cx="4114800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1" y="8342714"/>
            <a:ext cx="2743200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B6837-40B5-4D96-A202-68A78D336BB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93542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34995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solidFill>
                  <a:srgbClr val="FF0000"/>
                </a:solidFill>
              </a:rPr>
              <a:t>Supplementary</a:t>
            </a:r>
            <a:r>
              <a:rPr lang="zh-CN" altLang="en-US" sz="2400" b="1" dirty="0" smtClean="0">
                <a:solidFill>
                  <a:srgbClr val="FF0000"/>
                </a:solidFill>
              </a:rPr>
              <a:t>：</a:t>
            </a:r>
            <a:r>
              <a:rPr lang="en-US" altLang="zh-CN" sz="2400" b="1" dirty="0" smtClean="0">
                <a:solidFill>
                  <a:srgbClr val="FF0000"/>
                </a:solidFill>
              </a:rPr>
              <a:t> </a:t>
            </a:r>
            <a:r>
              <a:rPr lang="en-US" altLang="zh-CN" sz="2400" b="1" dirty="0" smtClean="0">
                <a:solidFill>
                  <a:srgbClr val="FF0000"/>
                </a:solidFill>
              </a:rPr>
              <a:t>Table </a:t>
            </a:r>
            <a:r>
              <a:rPr lang="en-US" altLang="zh-CN" sz="2400" b="1" dirty="0" smtClean="0">
                <a:solidFill>
                  <a:srgbClr val="FF0000"/>
                </a:solidFill>
              </a:rPr>
              <a:t>1</a:t>
            </a:r>
            <a:endParaRPr lang="zh-CN" altLang="en-US" sz="2400" b="1" dirty="0">
              <a:solidFill>
                <a:srgbClr val="FF0000"/>
              </a:solidFill>
            </a:endParaRPr>
          </a:p>
        </p:txBody>
      </p:sp>
      <p:graphicFrame>
        <p:nvGraphicFramePr>
          <p:cNvPr id="7" name="表格 6"/>
          <p:cNvGraphicFramePr>
            <a:graphicFrameLocks noGrp="1"/>
          </p:cNvGraphicFramePr>
          <p:nvPr/>
        </p:nvGraphicFramePr>
        <p:xfrm>
          <a:off x="1083732" y="2020710"/>
          <a:ext cx="9979380" cy="348826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326460"/>
                <a:gridCol w="3326460"/>
                <a:gridCol w="3326460"/>
              </a:tblGrid>
              <a:tr h="761892"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T</a:t>
                      </a: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ABLE</a:t>
                      </a:r>
                      <a:r>
                        <a:rPr kumimoji="0" lang="en-US" altLang="zh-CN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1: Database analysis of GTP</a:t>
                      </a:r>
                      <a:r>
                        <a:rPr kumimoji="0" lang="en-US" altLang="zh-CN" sz="2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</a:t>
                      </a:r>
                      <a:endParaRPr kumimoji="0" lang="en-US" altLang="zh-CN" sz="4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45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omponents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ompounds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b="1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Target Proteins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45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adix Paeoniae Alba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Galuteolin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TNF-α, IL-2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45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Radix Puerariae 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Arachidic acid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PPAR-γ, PPAR-α, PPAR-δ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45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Carthamus Tinctorius 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Arachidic acid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PPAR-γ, PPAR-α, PPAR-δ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45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Herba Lycopodii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latin typeface="Times New Roman"/>
                          <a:ea typeface="宋体"/>
                          <a:cs typeface="Times New Roman"/>
                        </a:rPr>
                        <a:t>Lycopene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latin typeface="Times New Roman"/>
                          <a:ea typeface="宋体"/>
                          <a:cs typeface="Times New Roman"/>
                        </a:rPr>
                        <a:t>  AR protein, ENRα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8</TotalTime>
  <Words>48</Words>
  <Application>Microsoft Office PowerPoint</Application>
  <PresentationFormat>自定义</PresentationFormat>
  <Paragraphs>1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hp</cp:lastModifiedBy>
  <cp:revision>78</cp:revision>
  <dcterms:created xsi:type="dcterms:W3CDTF">2017-04-27T19:23:26Z</dcterms:created>
  <dcterms:modified xsi:type="dcterms:W3CDTF">2017-09-25T12:26:01Z</dcterms:modified>
</cp:coreProperties>
</file>